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65547" y="1900246"/>
              <a:ext cx="4865663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65547" y="5490315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65547" y="4332601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65547" y="3174888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65547" y="2017175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69776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415041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560306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1465547" y="4911458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465547" y="3753745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65547" y="2596031"/>
              <a:ext cx="4865663" cy="0"/>
            </a:xfrm>
            <a:custGeom>
              <a:avLst/>
              <a:pathLst>
                <a:path w="4865663" h="0">
                  <a:moveTo>
                    <a:pt x="0" y="0"/>
                  </a:moveTo>
                  <a:lnTo>
                    <a:pt x="4865663" y="0"/>
                  </a:ln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97143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342408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487674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632939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4834614" y="4031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834614" y="4031596"/>
              <a:ext cx="0" cy="1782878"/>
            </a:xfrm>
            <a:custGeom>
              <a:avLst/>
              <a:pathLst>
                <a:path w="0" h="1782878">
                  <a:moveTo>
                    <a:pt x="0" y="0"/>
                  </a:moveTo>
                  <a:lnTo>
                    <a:pt x="0" y="17828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4834614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256154" y="3626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256154" y="3626396"/>
              <a:ext cx="0" cy="509393"/>
            </a:xfrm>
            <a:custGeom>
              <a:avLst/>
              <a:pathLst>
                <a:path w="0" h="509393">
                  <a:moveTo>
                    <a:pt x="0" y="0"/>
                  </a:moveTo>
                  <a:lnTo>
                    <a:pt x="0" y="5093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256154" y="4135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631817" y="3591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631817" y="3591665"/>
              <a:ext cx="0" cy="416776"/>
            </a:xfrm>
            <a:custGeom>
              <a:avLst/>
              <a:pathLst>
                <a:path w="0" h="416776">
                  <a:moveTo>
                    <a:pt x="0" y="0"/>
                  </a:moveTo>
                  <a:lnTo>
                    <a:pt x="0" y="4167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3631817" y="40084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986839" y="2978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986839" y="2978077"/>
              <a:ext cx="0" cy="532548"/>
            </a:xfrm>
            <a:custGeom>
              <a:avLst/>
              <a:pathLst>
                <a:path w="0" h="532548">
                  <a:moveTo>
                    <a:pt x="0" y="0"/>
                  </a:moveTo>
                  <a:lnTo>
                    <a:pt x="0" y="5325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986839" y="3510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938023" y="39274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938023" y="3927402"/>
              <a:ext cx="0" cy="439931"/>
            </a:xfrm>
            <a:custGeom>
              <a:avLst/>
              <a:pathLst>
                <a:path w="0" h="439931">
                  <a:moveTo>
                    <a:pt x="0" y="0"/>
                  </a:moveTo>
                  <a:lnTo>
                    <a:pt x="0" y="4399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938023" y="4367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3111767" y="3198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3111767" y="3198042"/>
              <a:ext cx="0" cy="717782"/>
            </a:xfrm>
            <a:custGeom>
              <a:avLst/>
              <a:pathLst>
                <a:path w="0" h="717782">
                  <a:moveTo>
                    <a:pt x="0" y="0"/>
                  </a:moveTo>
                  <a:lnTo>
                    <a:pt x="0" y="7177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3111767" y="3915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3245411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3245411" y="2086637"/>
              <a:ext cx="0" cy="879862"/>
            </a:xfrm>
            <a:custGeom>
              <a:avLst/>
              <a:pathLst>
                <a:path w="0" h="879862">
                  <a:moveTo>
                    <a:pt x="0" y="0"/>
                  </a:moveTo>
                  <a:lnTo>
                    <a:pt x="0" y="8798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3245411" y="2966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074572" y="3568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074572" y="3568510"/>
              <a:ext cx="0" cy="463085"/>
            </a:xfrm>
            <a:custGeom>
              <a:avLst/>
              <a:pathLst>
                <a:path w="0" h="463085">
                  <a:moveTo>
                    <a:pt x="0" y="0"/>
                  </a:moveTo>
                  <a:lnTo>
                    <a:pt x="0" y="4630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074572" y="4031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843904" y="3742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3843904" y="3742167"/>
              <a:ext cx="0" cy="810399"/>
            </a:xfrm>
            <a:custGeom>
              <a:avLst/>
              <a:pathLst>
                <a:path w="0" h="810399">
                  <a:moveTo>
                    <a:pt x="0" y="0"/>
                  </a:moveTo>
                  <a:lnTo>
                    <a:pt x="0" y="8103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3843904" y="4552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5559488" y="3128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5559488" y="3128579"/>
              <a:ext cx="0" cy="856707"/>
            </a:xfrm>
            <a:custGeom>
              <a:avLst/>
              <a:pathLst>
                <a:path w="0" h="856707">
                  <a:moveTo>
                    <a:pt x="0" y="0"/>
                  </a:moveTo>
                  <a:lnTo>
                    <a:pt x="0" y="8567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5559488" y="3985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943259" y="3661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943259" y="3661128"/>
              <a:ext cx="0" cy="416776"/>
            </a:xfrm>
            <a:custGeom>
              <a:avLst/>
              <a:pathLst>
                <a:path w="0" h="416776">
                  <a:moveTo>
                    <a:pt x="0" y="0"/>
                  </a:moveTo>
                  <a:lnTo>
                    <a:pt x="0" y="4167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943259" y="4077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5456350" y="49230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4212878" y="4923035"/>
              <a:ext cx="1243471" cy="0"/>
            </a:xfrm>
            <a:custGeom>
              <a:avLst/>
              <a:pathLst>
                <a:path w="1243471" h="0">
                  <a:moveTo>
                    <a:pt x="12434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4212878" y="49230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36516" y="38810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975792" y="3881093"/>
              <a:ext cx="560724" cy="0"/>
            </a:xfrm>
            <a:custGeom>
              <a:avLst/>
              <a:pathLst>
                <a:path w="560724" h="0">
                  <a:moveTo>
                    <a:pt x="5607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975792" y="38810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3859884" y="3800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3403750" y="3800053"/>
              <a:ext cx="456133" cy="0"/>
            </a:xfrm>
            <a:custGeom>
              <a:avLst/>
              <a:pathLst>
                <a:path w="456133" h="0">
                  <a:moveTo>
                    <a:pt x="4561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3403750" y="3800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3328212" y="32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645465" y="3244351"/>
              <a:ext cx="682747" cy="0"/>
            </a:xfrm>
            <a:custGeom>
              <a:avLst/>
              <a:pathLst>
                <a:path w="682747" h="0">
                  <a:moveTo>
                    <a:pt x="68274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645465" y="32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189332" y="41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686714" y="4147367"/>
              <a:ext cx="502618" cy="0"/>
            </a:xfrm>
            <a:custGeom>
              <a:avLst/>
              <a:pathLst>
                <a:path w="502618" h="0">
                  <a:moveTo>
                    <a:pt x="5026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686714" y="41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3428445" y="3556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795088" y="3556933"/>
              <a:ext cx="633356" cy="0"/>
            </a:xfrm>
            <a:custGeom>
              <a:avLst/>
              <a:pathLst>
                <a:path w="633356" h="0">
                  <a:moveTo>
                    <a:pt x="63335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795088" y="3556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3691376" y="2526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799446" y="2526568"/>
              <a:ext cx="891929" cy="0"/>
            </a:xfrm>
            <a:custGeom>
              <a:avLst/>
              <a:pathLst>
                <a:path w="891929" h="0">
                  <a:moveTo>
                    <a:pt x="89192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799446" y="2526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314260" y="3800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34884" y="3800053"/>
              <a:ext cx="479375" cy="0"/>
            </a:xfrm>
            <a:custGeom>
              <a:avLst/>
              <a:pathLst>
                <a:path w="479375" h="0">
                  <a:moveTo>
                    <a:pt x="47937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34884" y="3800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4345070" y="41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3342739" y="4147367"/>
              <a:ext cx="1002330" cy="0"/>
            </a:xfrm>
            <a:custGeom>
              <a:avLst/>
              <a:pathLst>
                <a:path w="1002330" h="0">
                  <a:moveTo>
                    <a:pt x="10023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3342739" y="41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6110044" y="3556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5008933" y="3556933"/>
              <a:ext cx="1101111" cy="0"/>
            </a:xfrm>
            <a:custGeom>
              <a:avLst/>
              <a:pathLst>
                <a:path w="1101111" h="0">
                  <a:moveTo>
                    <a:pt x="11011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5008933" y="3556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3169873" y="3869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716645" y="3869516"/>
              <a:ext cx="453227" cy="0"/>
            </a:xfrm>
            <a:custGeom>
              <a:avLst/>
              <a:pathLst>
                <a:path w="453227" h="0">
                  <a:moveTo>
                    <a:pt x="45322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716645" y="3869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t86"/>
            <p:cNvSpPr/>
            <p:nvPr/>
          </p:nvSpPr>
          <p:spPr>
            <a:xfrm>
              <a:off x="4809788" y="48982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t87"/>
            <p:cNvSpPr/>
            <p:nvPr/>
          </p:nvSpPr>
          <p:spPr>
            <a:xfrm>
              <a:off x="2231328" y="38562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t88"/>
            <p:cNvSpPr/>
            <p:nvPr/>
          </p:nvSpPr>
          <p:spPr>
            <a:xfrm>
              <a:off x="3606991" y="37752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t89"/>
            <p:cNvSpPr/>
            <p:nvPr/>
          </p:nvSpPr>
          <p:spPr>
            <a:xfrm>
              <a:off x="2962013" y="3219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t90"/>
            <p:cNvSpPr/>
            <p:nvPr/>
          </p:nvSpPr>
          <p:spPr>
            <a:xfrm>
              <a:off x="1913197" y="41225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t91"/>
            <p:cNvSpPr/>
            <p:nvPr/>
          </p:nvSpPr>
          <p:spPr>
            <a:xfrm>
              <a:off x="3086941" y="35321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t92"/>
            <p:cNvSpPr/>
            <p:nvPr/>
          </p:nvSpPr>
          <p:spPr>
            <a:xfrm>
              <a:off x="3220585" y="25017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t93"/>
            <p:cNvSpPr/>
            <p:nvPr/>
          </p:nvSpPr>
          <p:spPr>
            <a:xfrm>
              <a:off x="2049746" y="37752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t94"/>
            <p:cNvSpPr/>
            <p:nvPr/>
          </p:nvSpPr>
          <p:spPr>
            <a:xfrm>
              <a:off x="3819078" y="41225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t95"/>
            <p:cNvSpPr/>
            <p:nvPr/>
          </p:nvSpPr>
          <p:spPr>
            <a:xfrm>
              <a:off x="5534662" y="35321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t96"/>
            <p:cNvSpPr/>
            <p:nvPr/>
          </p:nvSpPr>
          <p:spPr>
            <a:xfrm>
              <a:off x="2918433" y="38446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465547" y="3727949"/>
              <a:ext cx="4865663" cy="21593"/>
            </a:xfrm>
            <a:custGeom>
              <a:avLst/>
              <a:pathLst>
                <a:path w="4865663" h="21593">
                  <a:moveTo>
                    <a:pt x="0" y="21593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465547" y="3436423"/>
              <a:ext cx="4865663" cy="474537"/>
            </a:xfrm>
            <a:custGeom>
              <a:avLst/>
              <a:pathLst>
                <a:path w="4865663" h="474537">
                  <a:moveTo>
                    <a:pt x="0" y="474537"/>
                  </a:moveTo>
                  <a:lnTo>
                    <a:pt x="4865663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465547" y="3770485"/>
              <a:ext cx="4865663" cy="86031"/>
            </a:xfrm>
            <a:custGeom>
              <a:avLst/>
              <a:pathLst>
                <a:path w="4865663" h="86031">
                  <a:moveTo>
                    <a:pt x="0" y="0"/>
                  </a:moveTo>
                  <a:lnTo>
                    <a:pt x="4865663" y="86031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465547" y="3770325"/>
              <a:ext cx="4865663" cy="85211"/>
            </a:xfrm>
            <a:custGeom>
              <a:avLst/>
              <a:pathLst>
                <a:path w="4865663" h="85211">
                  <a:moveTo>
                    <a:pt x="0" y="0"/>
                  </a:moveTo>
                  <a:lnTo>
                    <a:pt x="4865663" y="85211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tx101"/>
            <p:cNvSpPr/>
            <p:nvPr/>
          </p:nvSpPr>
          <p:spPr>
            <a:xfrm>
              <a:off x="1148183" y="4869766"/>
              <a:ext cx="254734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1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1185400" y="3712053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1185400" y="2554340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1</a:t>
              </a:r>
            </a:p>
          </p:txBody>
        </p:sp>
        <p:sp>
          <p:nvSpPr>
            <p:cNvPr id="105" name="pl104"/>
            <p:cNvSpPr/>
            <p:nvPr/>
          </p:nvSpPr>
          <p:spPr>
            <a:xfrm>
              <a:off x="1430753" y="49114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430753" y="37537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430753" y="25960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97143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3424087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4876741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6329395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tx111"/>
            <p:cNvSpPr/>
            <p:nvPr/>
          </p:nvSpPr>
          <p:spPr>
            <a:xfrm>
              <a:off x="1893753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113" name="tx112"/>
            <p:cNvSpPr/>
            <p:nvPr/>
          </p:nvSpPr>
          <p:spPr>
            <a:xfrm>
              <a:off x="3346407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14" name="tx113"/>
            <p:cNvSpPr/>
            <p:nvPr/>
          </p:nvSpPr>
          <p:spPr>
            <a:xfrm>
              <a:off x="4799060" y="6061750"/>
              <a:ext cx="155361" cy="8174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115" name="tx114"/>
            <p:cNvSpPr/>
            <p:nvPr/>
          </p:nvSpPr>
          <p:spPr>
            <a:xfrm>
              <a:off x="6251714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16" name="tx115"/>
            <p:cNvSpPr/>
            <p:nvPr/>
          </p:nvSpPr>
          <p:spPr>
            <a:xfrm>
              <a:off x="2285894" y="6170706"/>
              <a:ext cx="3224969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Myocardial infarction || id:finn-b-I9_MI</a:t>
              </a:r>
            </a:p>
          </p:txBody>
        </p:sp>
        <p:sp>
          <p:nvSpPr>
            <p:cNvPr id="117" name="tx116"/>
            <p:cNvSpPr/>
            <p:nvPr/>
          </p:nvSpPr>
          <p:spPr>
            <a:xfrm rot="-5400000">
              <a:off x="-947424" y="3885003"/>
              <a:ext cx="3931722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Serum uric acid levels || id:ebi-a-GCST90018977</a:t>
              </a:r>
            </a:p>
          </p:txBody>
        </p:sp>
        <p:sp>
          <p:nvSpPr>
            <p:cNvPr id="118" name="rc117"/>
            <p:cNvSpPr/>
            <p:nvPr/>
          </p:nvSpPr>
          <p:spPr>
            <a:xfrm>
              <a:off x="1663148" y="983989"/>
              <a:ext cx="4470462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19" name="tx118"/>
            <p:cNvSpPr/>
            <p:nvPr/>
          </p:nvSpPr>
          <p:spPr>
            <a:xfrm>
              <a:off x="1732737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120" name="rc119"/>
            <p:cNvSpPr/>
            <p:nvPr/>
          </p:nvSpPr>
          <p:spPr>
            <a:xfrm>
              <a:off x="1732737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1732737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rc121"/>
            <p:cNvSpPr/>
            <p:nvPr/>
          </p:nvSpPr>
          <p:spPr>
            <a:xfrm>
              <a:off x="1732737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1732737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rc123"/>
            <p:cNvSpPr/>
            <p:nvPr/>
          </p:nvSpPr>
          <p:spPr>
            <a:xfrm>
              <a:off x="4905234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4905234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rc125"/>
            <p:cNvSpPr/>
            <p:nvPr/>
          </p:nvSpPr>
          <p:spPr>
            <a:xfrm>
              <a:off x="4905234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905234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tx127"/>
            <p:cNvSpPr/>
            <p:nvPr/>
          </p:nvSpPr>
          <p:spPr>
            <a:xfrm>
              <a:off x="2021782" y="1297410"/>
              <a:ext cx="2813863" cy="1048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 (multiplicative random effects)</a:t>
              </a:r>
            </a:p>
          </p:txBody>
        </p:sp>
        <p:sp>
          <p:nvSpPr>
            <p:cNvPr id="129" name="tx128"/>
            <p:cNvSpPr/>
            <p:nvPr/>
          </p:nvSpPr>
          <p:spPr>
            <a:xfrm>
              <a:off x="2021782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30" name="tx129"/>
            <p:cNvSpPr/>
            <p:nvPr/>
          </p:nvSpPr>
          <p:spPr>
            <a:xfrm>
              <a:off x="5194279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31" name="tx130"/>
            <p:cNvSpPr/>
            <p:nvPr/>
          </p:nvSpPr>
          <p:spPr>
            <a:xfrm>
              <a:off x="5194279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4-02-13T02:03:02Z</dcterms:modified>
  <cp:category/>
</cp:coreProperties>
</file>